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2" r:id="rId2"/>
    <p:sldId id="263" r:id="rId3"/>
    <p:sldId id="264" r:id="rId4"/>
    <p:sldId id="265" r:id="rId5"/>
    <p:sldId id="266" r:id="rId6"/>
    <p:sldId id="267" r:id="rId7"/>
    <p:sldId id="268" r:id="rId8"/>
    <p:sldId id="269" r:id="rId9"/>
    <p:sldId id="270" r:id="rId10"/>
    <p:sldId id="271" r:id="rId11"/>
  </p:sldIdLst>
  <p:sldSz cx="7772400" cy="10058400"/>
  <p:notesSz cx="6858000" cy="9144000"/>
  <p:defaultTextStyle>
    <a:defPPr>
      <a:defRPr lang="en-US"/>
    </a:defPPr>
    <a:lvl1pPr marL="0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8" autoAdjust="0"/>
    <p:restoredTop sz="94662" autoAdjust="0"/>
  </p:normalViewPr>
  <p:slideViewPr>
    <p:cSldViewPr>
      <p:cViewPr>
        <p:scale>
          <a:sx n="150" d="100"/>
          <a:sy n="150" d="100"/>
        </p:scale>
        <p:origin x="372" y="1224"/>
      </p:cViewPr>
      <p:guideLst>
        <p:guide orient="horz" pos="3168"/>
        <p:guide pos="244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customXml" Target="../customXml/item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customXml" Target="../customXml/item3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3FD9DE-DA47-43C6-99AB-176668588C8A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C38908-BB3F-4F1A-9AC5-410DC4F20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529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6"/>
            <a:ext cx="6606540" cy="21560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94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8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7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64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5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102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052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26242" y="537846"/>
            <a:ext cx="1311593" cy="114414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1466" y="537846"/>
            <a:ext cx="3805238" cy="114414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013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963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94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1882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282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3764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470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564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56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0752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080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1466" y="3129281"/>
            <a:ext cx="2558415" cy="8849996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9421" y="3129281"/>
            <a:ext cx="2558415" cy="8849996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836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8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8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963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978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090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1" y="400474"/>
            <a:ext cx="2557066" cy="170434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3" y="400474"/>
            <a:ext cx="4344988" cy="8584566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1" y="2104814"/>
            <a:ext cx="2557066" cy="6880226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103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1"/>
            <a:ext cx="4663440" cy="831216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600"/>
            </a:lvl1pPr>
            <a:lvl2pPr marL="509412" indent="0">
              <a:buNone/>
              <a:defRPr sz="3100"/>
            </a:lvl2pPr>
            <a:lvl3pPr marL="1018824" indent="0">
              <a:buNone/>
              <a:defRPr sz="2700"/>
            </a:lvl3pPr>
            <a:lvl4pPr marL="1528237" indent="0">
              <a:buNone/>
              <a:defRPr sz="2200"/>
            </a:lvl4pPr>
            <a:lvl5pPr marL="2037649" indent="0">
              <a:buNone/>
              <a:defRPr sz="2200"/>
            </a:lvl5pPr>
            <a:lvl6pPr marL="2547061" indent="0">
              <a:buNone/>
              <a:defRPr sz="2200"/>
            </a:lvl6pPr>
            <a:lvl7pPr marL="3056473" indent="0">
              <a:buNone/>
              <a:defRPr sz="2200"/>
            </a:lvl7pPr>
            <a:lvl8pPr marL="3565886" indent="0">
              <a:buNone/>
              <a:defRPr sz="2200"/>
            </a:lvl8pPr>
            <a:lvl9pPr marL="4075298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7"/>
            <a:ext cx="4663440" cy="1180464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032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101882" tIns="50941" rIns="101882" bIns="509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2"/>
            <a:ext cx="6995160" cy="6638079"/>
          </a:xfrm>
          <a:prstGeom prst="rect">
            <a:avLst/>
          </a:prstGeom>
        </p:spPr>
        <p:txBody>
          <a:bodyPr vert="horz" lIns="101882" tIns="50941" rIns="101882" bIns="509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8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6A4CA-AF51-4434-8372-04BD3A3F1218}" type="datetimeFigureOut">
              <a:rPr lang="en-US" smtClean="0"/>
              <a:t>7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8"/>
            <a:ext cx="24612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8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ECC9EE-8818-41A2-90FE-5E27C3594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512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8824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2059" indent="-382059" algn="l" defTabSz="1018824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27795" indent="-318383" algn="l" defTabSz="1018824" rtl="0" eaLnBrk="1" latinLnBrk="0" hangingPunct="1">
        <a:spcBef>
          <a:spcPct val="20000"/>
        </a:spcBef>
        <a:buFont typeface="Arial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73531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782943" indent="-254706" algn="l" defTabSz="1018824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92355" indent="-254706" algn="l" defTabSz="1018824" rtl="0" eaLnBrk="1" latinLnBrk="0" hangingPunct="1">
        <a:spcBef>
          <a:spcPct val="20000"/>
        </a:spcBef>
        <a:buFont typeface="Arial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1767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11180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20592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004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09412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824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28237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37649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47061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56473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565886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075298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7752" y="1257179"/>
            <a:ext cx="4041648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010317" y="1340736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15948" y="1473216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877408" y="1573244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581150" y="1682786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57233" y="178281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46093" y="188284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741222" y="197888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57233" y="209835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57233" y="22017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829644" y="2295442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44334" y="24095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21330" y="2509583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38268" y="262228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76283" y="272417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76283" y="282419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781276" y="375291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781276" y="364344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776283" y="293753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757233" y="30375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81276" y="314331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80479" y="32480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082352" y="3348083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81276" y="344339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781276" y="354342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781276" y="385809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780479" y="396551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781276" y="406554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781276" y="416557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566413" y="427699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781276" y="5143677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552676" y="438173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552676" y="446877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552676" y="459153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552676" y="469155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552676" y="478337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552676" y="48916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820258" y="5243704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996701" y="5343731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524000" y="54545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552676" y="5558854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552676" y="576502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082352" y="5654568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009876" y="5965074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552676" y="498343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705076" y="5869765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009876" y="6065101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996701" y="6174564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857476" y="6274592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857476" y="637462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820258" y="648643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820258" y="6581745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066801" y="6858000"/>
            <a:ext cx="56388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l Figure 1: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ClustalW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alignment of GSNOR proteins from various plant species, human,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, and yeas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grape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. pusill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icromona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Sitka spruce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. domestic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apple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purple false brome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witchgras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foxtail mille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sorghum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cucumber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monkey flower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hellungiell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turnip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apsell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Arabidopsis lyrata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orange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clementine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eucalyptus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papaya. 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Aquilegia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cocoa tree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strawberry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castor oil plan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cassava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ccomyx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Volvox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0976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56"/>
          <p:cNvSpPr txBox="1"/>
          <p:nvPr/>
        </p:nvSpPr>
        <p:spPr>
          <a:xfrm>
            <a:off x="1400717" y="1721736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306348" y="1854216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267808" y="1954244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971550" y="2063786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147633" y="216381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136493" y="226384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131622" y="235988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147633" y="247935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147633" y="25827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220044" y="2676442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134734" y="27905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211730" y="2890583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128668" y="300328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166683" y="310517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166683" y="320519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171676" y="413391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171676" y="402444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166683" y="331853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147633" y="34185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171676" y="352431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170879" y="36290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472752" y="3729083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1171676" y="382439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171676" y="392442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171676" y="423909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1170879" y="434651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1171676" y="444654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171676" y="454657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956813" y="465799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171676" y="5524677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943076" y="476273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943076" y="484977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943076" y="497253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943076" y="507255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943076" y="516437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943076" y="52726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210658" y="5624704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387101" y="5724731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914400" y="58355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943076" y="5939854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943076" y="614602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472752" y="6035568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1400276" y="6346074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943076" y="536443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1095476" y="6250765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1400276" y="6446101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387101" y="6555564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247876" y="6655592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247876" y="675562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210658" y="686743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210658" y="6962745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42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0893" y="1647055"/>
            <a:ext cx="1828800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2" name="TextBox 161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0455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6752" y="1905000"/>
            <a:ext cx="4041648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" name="TextBox 111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562986" y="1978999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468617" y="2111479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430077" y="2211507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133819" y="2321049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309902" y="242107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298762" y="252110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293891" y="261714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309902" y="273661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309902" y="284002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382313" y="2933705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297003" y="304781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373999" y="3147846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290937" y="326055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328952" y="336243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328952" y="346246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333945" y="439117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333945" y="428171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328952" y="357579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309902" y="367582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333945" y="378157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333148" y="388631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1635021" y="3986346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333945" y="408165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333945" y="418168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1333945" y="449635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1333148" y="460377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333945" y="470380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1333945" y="480383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119082" y="491525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1371600" y="5743545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1105345" y="5020001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1105345" y="510703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1105345" y="522979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1105345" y="5329821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105345" y="5421641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105345" y="552987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372927" y="5881967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1549370" y="5981994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076669" y="609277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1105345" y="6197117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105345" y="640328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1635021" y="6292831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1562545" y="6603337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1105345" y="562169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1257745" y="6508028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562545" y="6703364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549370" y="6812827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410145" y="6912855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410145" y="7012883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372927" y="7124699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1372927" y="7220008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0626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2015" y="1403386"/>
            <a:ext cx="4041648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" name="TextBox 111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857917" y="1493136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757233" y="1600200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725008" y="1700227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428750" y="1816984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604833" y="191701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604833" y="203125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588822" y="213128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617736" y="223130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604833" y="23541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677244" y="2447842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591934" y="25619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668930" y="2661983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585868" y="277468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623883" y="287657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623883" y="297659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628876" y="390531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628876" y="379584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623883" y="308993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604833" y="31899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628876" y="329571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628079" y="34004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1929952" y="3500483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628876" y="359579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628876" y="369582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1628876" y="401049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1628079" y="411791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628876" y="421794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1628876" y="431797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414013" y="442939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1641816" y="5257800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1400276" y="453413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1400276" y="462117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1400276" y="474393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1400276" y="484395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400276" y="493577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400276" y="50440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667858" y="5371555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1844301" y="5471582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371600" y="5582364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1400276" y="568670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400276" y="5892871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1929952" y="5782419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1857476" y="6117474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1400276" y="513583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1552676" y="5997616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857476" y="6217501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844301" y="6326964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705076" y="6426992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705076" y="652702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667858" y="663883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1667858" y="6734145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0626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6752" y="1783080"/>
            <a:ext cx="4041648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" name="TextBox 111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Flowchart: Merge 112"/>
          <p:cNvSpPr/>
          <p:nvPr/>
        </p:nvSpPr>
        <p:spPr>
          <a:xfrm>
            <a:off x="2689859" y="1841930"/>
            <a:ext cx="45719" cy="64409"/>
          </a:xfrm>
          <a:prstGeom prst="flowChartMerg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4" name="TextBox 113"/>
          <p:cNvSpPr txBox="1"/>
          <p:nvPr/>
        </p:nvSpPr>
        <p:spPr>
          <a:xfrm>
            <a:off x="1553117" y="1874136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447800" y="1974163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447800" y="2085945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143000" y="2182863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295400" y="229883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300271" y="239236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295400" y="248840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311411" y="260787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300033" y="27351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372444" y="2828842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295400" y="292886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378408" y="3022546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274718" y="312257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319083" y="325757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319083" y="335759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324076" y="428631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324076" y="417684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319083" y="347093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300033" y="35709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1324076" y="367671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323279" y="37814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625152" y="3881483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1324076" y="397679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1324076" y="407682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324076" y="439149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1323279" y="449891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324076" y="459894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1324076" y="469897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1109213" y="481039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1309137" y="5638800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1095476" y="491513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1095476" y="500217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095476" y="512493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095476" y="522495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095476" y="531677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1095476" y="54250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348119" y="5738827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1524562" y="5838854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066800" y="594963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1080537" y="6053977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1143000" y="62775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1600200" y="6177485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1569250" y="6503925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066800" y="5539312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296760" y="6400800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552676" y="6598501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539501" y="6707964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400276" y="6807992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1400276" y="690802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1363058" y="701983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1363058" y="7115145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0626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8152" y="1509144"/>
            <a:ext cx="4041648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" name="TextBox 111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7" name="TextBox 316"/>
          <p:cNvSpPr txBox="1"/>
          <p:nvPr/>
        </p:nvSpPr>
        <p:spPr>
          <a:xfrm>
            <a:off x="1324517" y="1600200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8" name="TextBox 317"/>
          <p:cNvSpPr txBox="1"/>
          <p:nvPr/>
        </p:nvSpPr>
        <p:spPr>
          <a:xfrm>
            <a:off x="1219200" y="1699377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9" name="TextBox 318"/>
          <p:cNvSpPr txBox="1"/>
          <p:nvPr/>
        </p:nvSpPr>
        <p:spPr>
          <a:xfrm>
            <a:off x="1219200" y="1791463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0" name="TextBox 319"/>
          <p:cNvSpPr txBox="1"/>
          <p:nvPr/>
        </p:nvSpPr>
        <p:spPr>
          <a:xfrm>
            <a:off x="914400" y="1902577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1" name="TextBox 320"/>
          <p:cNvSpPr txBox="1"/>
          <p:nvPr/>
        </p:nvSpPr>
        <p:spPr>
          <a:xfrm>
            <a:off x="1090483" y="200260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2" name="TextBox 321"/>
          <p:cNvSpPr txBox="1"/>
          <p:nvPr/>
        </p:nvSpPr>
        <p:spPr>
          <a:xfrm>
            <a:off x="1079343" y="210263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3" name="TextBox 322"/>
          <p:cNvSpPr txBox="1"/>
          <p:nvPr/>
        </p:nvSpPr>
        <p:spPr>
          <a:xfrm>
            <a:off x="1074472" y="219867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4" name="TextBox 323"/>
          <p:cNvSpPr txBox="1"/>
          <p:nvPr/>
        </p:nvSpPr>
        <p:spPr>
          <a:xfrm>
            <a:off x="1085765" y="232400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5" name="TextBox 324"/>
          <p:cNvSpPr txBox="1"/>
          <p:nvPr/>
        </p:nvSpPr>
        <p:spPr>
          <a:xfrm>
            <a:off x="1085765" y="242741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6" name="TextBox 325"/>
          <p:cNvSpPr txBox="1"/>
          <p:nvPr/>
        </p:nvSpPr>
        <p:spPr>
          <a:xfrm>
            <a:off x="1158176" y="2521098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7" name="TextBox 326"/>
          <p:cNvSpPr txBox="1"/>
          <p:nvPr/>
        </p:nvSpPr>
        <p:spPr>
          <a:xfrm>
            <a:off x="1072866" y="263521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8" name="TextBox 327"/>
          <p:cNvSpPr txBox="1"/>
          <p:nvPr/>
        </p:nvSpPr>
        <p:spPr>
          <a:xfrm>
            <a:off x="1149862" y="2735239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9" name="TextBox 328"/>
          <p:cNvSpPr txBox="1"/>
          <p:nvPr/>
        </p:nvSpPr>
        <p:spPr>
          <a:xfrm>
            <a:off x="1066800" y="284794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0" name="TextBox 329"/>
          <p:cNvSpPr txBox="1"/>
          <p:nvPr/>
        </p:nvSpPr>
        <p:spPr>
          <a:xfrm>
            <a:off x="1090483" y="298363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1" name="TextBox 330"/>
          <p:cNvSpPr txBox="1"/>
          <p:nvPr/>
        </p:nvSpPr>
        <p:spPr>
          <a:xfrm>
            <a:off x="1090483" y="308366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2" name="TextBox 331"/>
          <p:cNvSpPr txBox="1"/>
          <p:nvPr/>
        </p:nvSpPr>
        <p:spPr>
          <a:xfrm>
            <a:off x="1095476" y="401237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3" name="TextBox 332"/>
          <p:cNvSpPr txBox="1"/>
          <p:nvPr/>
        </p:nvSpPr>
        <p:spPr>
          <a:xfrm>
            <a:off x="1095476" y="390291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4" name="TextBox 333"/>
          <p:cNvSpPr txBox="1"/>
          <p:nvPr/>
        </p:nvSpPr>
        <p:spPr>
          <a:xfrm>
            <a:off x="1090483" y="319699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5" name="TextBox 334"/>
          <p:cNvSpPr txBox="1"/>
          <p:nvPr/>
        </p:nvSpPr>
        <p:spPr>
          <a:xfrm>
            <a:off x="1071433" y="329702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6" name="TextBox 335"/>
          <p:cNvSpPr txBox="1"/>
          <p:nvPr/>
        </p:nvSpPr>
        <p:spPr>
          <a:xfrm>
            <a:off x="1095476" y="340277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7" name="TextBox 336"/>
          <p:cNvSpPr txBox="1"/>
          <p:nvPr/>
        </p:nvSpPr>
        <p:spPr>
          <a:xfrm>
            <a:off x="1094679" y="350752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8" name="TextBox 337"/>
          <p:cNvSpPr txBox="1"/>
          <p:nvPr/>
        </p:nvSpPr>
        <p:spPr>
          <a:xfrm>
            <a:off x="1396552" y="3607547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9" name="TextBox 338"/>
          <p:cNvSpPr txBox="1"/>
          <p:nvPr/>
        </p:nvSpPr>
        <p:spPr>
          <a:xfrm>
            <a:off x="1095476" y="37028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0" name="TextBox 339"/>
          <p:cNvSpPr txBox="1"/>
          <p:nvPr/>
        </p:nvSpPr>
        <p:spPr>
          <a:xfrm>
            <a:off x="1095476" y="380288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1" name="TextBox 340"/>
          <p:cNvSpPr txBox="1"/>
          <p:nvPr/>
        </p:nvSpPr>
        <p:spPr>
          <a:xfrm>
            <a:off x="1095476" y="411755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2" name="TextBox 341"/>
          <p:cNvSpPr txBox="1"/>
          <p:nvPr/>
        </p:nvSpPr>
        <p:spPr>
          <a:xfrm>
            <a:off x="1094679" y="422498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3" name="TextBox 342"/>
          <p:cNvSpPr txBox="1"/>
          <p:nvPr/>
        </p:nvSpPr>
        <p:spPr>
          <a:xfrm>
            <a:off x="1095476" y="432500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4" name="TextBox 343"/>
          <p:cNvSpPr txBox="1"/>
          <p:nvPr/>
        </p:nvSpPr>
        <p:spPr>
          <a:xfrm>
            <a:off x="1095476" y="442503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5" name="TextBox 344"/>
          <p:cNvSpPr txBox="1"/>
          <p:nvPr/>
        </p:nvSpPr>
        <p:spPr>
          <a:xfrm>
            <a:off x="880613" y="4536457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6" name="TextBox 345"/>
          <p:cNvSpPr txBox="1"/>
          <p:nvPr/>
        </p:nvSpPr>
        <p:spPr>
          <a:xfrm>
            <a:off x="1143000" y="5368323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7" name="TextBox 346"/>
          <p:cNvSpPr txBox="1"/>
          <p:nvPr/>
        </p:nvSpPr>
        <p:spPr>
          <a:xfrm>
            <a:off x="866876" y="4641202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8" name="TextBox 347"/>
          <p:cNvSpPr txBox="1"/>
          <p:nvPr/>
        </p:nvSpPr>
        <p:spPr>
          <a:xfrm>
            <a:off x="866876" y="4728239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9" name="TextBox 348"/>
          <p:cNvSpPr txBox="1"/>
          <p:nvPr/>
        </p:nvSpPr>
        <p:spPr>
          <a:xfrm>
            <a:off x="866876" y="4850994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0" name="TextBox 349"/>
          <p:cNvSpPr txBox="1"/>
          <p:nvPr/>
        </p:nvSpPr>
        <p:spPr>
          <a:xfrm>
            <a:off x="866876" y="4951022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1" name="TextBox 350"/>
          <p:cNvSpPr txBox="1"/>
          <p:nvPr/>
        </p:nvSpPr>
        <p:spPr>
          <a:xfrm>
            <a:off x="866876" y="5042842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2" name="TextBox 351"/>
          <p:cNvSpPr txBox="1"/>
          <p:nvPr/>
        </p:nvSpPr>
        <p:spPr>
          <a:xfrm>
            <a:off x="866876" y="5151077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3" name="TextBox 352"/>
          <p:cNvSpPr txBox="1"/>
          <p:nvPr/>
        </p:nvSpPr>
        <p:spPr>
          <a:xfrm>
            <a:off x="1181982" y="5468350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4" name="TextBox 353"/>
          <p:cNvSpPr txBox="1"/>
          <p:nvPr/>
        </p:nvSpPr>
        <p:spPr>
          <a:xfrm>
            <a:off x="1358425" y="5568377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5" name="TextBox 354"/>
          <p:cNvSpPr txBox="1"/>
          <p:nvPr/>
        </p:nvSpPr>
        <p:spPr>
          <a:xfrm>
            <a:off x="838200" y="566734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6" name="TextBox 355"/>
          <p:cNvSpPr txBox="1"/>
          <p:nvPr/>
        </p:nvSpPr>
        <p:spPr>
          <a:xfrm>
            <a:off x="838200" y="5800231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7" name="TextBox 356"/>
          <p:cNvSpPr txBox="1"/>
          <p:nvPr/>
        </p:nvSpPr>
        <p:spPr>
          <a:xfrm>
            <a:off x="866876" y="6024484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8" name="TextBox 357"/>
          <p:cNvSpPr txBox="1"/>
          <p:nvPr/>
        </p:nvSpPr>
        <p:spPr>
          <a:xfrm>
            <a:off x="1367876" y="5895945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9" name="TextBox 358"/>
          <p:cNvSpPr txBox="1"/>
          <p:nvPr/>
        </p:nvSpPr>
        <p:spPr>
          <a:xfrm>
            <a:off x="1324076" y="6224538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0" name="TextBox 359"/>
          <p:cNvSpPr txBox="1"/>
          <p:nvPr/>
        </p:nvSpPr>
        <p:spPr>
          <a:xfrm>
            <a:off x="866876" y="5242897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1" name="TextBox 360"/>
          <p:cNvSpPr txBox="1"/>
          <p:nvPr/>
        </p:nvSpPr>
        <p:spPr>
          <a:xfrm>
            <a:off x="1019276" y="6129229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2" name="TextBox 361"/>
          <p:cNvSpPr txBox="1"/>
          <p:nvPr/>
        </p:nvSpPr>
        <p:spPr>
          <a:xfrm>
            <a:off x="1324076" y="6324565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3" name="TextBox 362"/>
          <p:cNvSpPr txBox="1"/>
          <p:nvPr/>
        </p:nvSpPr>
        <p:spPr>
          <a:xfrm>
            <a:off x="1310901" y="6434028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4" name="TextBox 363"/>
          <p:cNvSpPr txBox="1"/>
          <p:nvPr/>
        </p:nvSpPr>
        <p:spPr>
          <a:xfrm>
            <a:off x="1171676" y="653405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5" name="TextBox 364"/>
          <p:cNvSpPr txBox="1"/>
          <p:nvPr/>
        </p:nvSpPr>
        <p:spPr>
          <a:xfrm>
            <a:off x="1171676" y="6634084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6" name="TextBox 365"/>
          <p:cNvSpPr txBox="1"/>
          <p:nvPr/>
        </p:nvSpPr>
        <p:spPr>
          <a:xfrm>
            <a:off x="1134458" y="674590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7" name="TextBox 366"/>
          <p:cNvSpPr txBox="1"/>
          <p:nvPr/>
        </p:nvSpPr>
        <p:spPr>
          <a:xfrm>
            <a:off x="1134458" y="6841209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964626" y="7022155"/>
            <a:ext cx="4055174" cy="1406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626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TextBox 111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Flowchart: Merge 56"/>
          <p:cNvSpPr/>
          <p:nvPr/>
        </p:nvSpPr>
        <p:spPr>
          <a:xfrm>
            <a:off x="2613659" y="2333767"/>
            <a:ext cx="45719" cy="64409"/>
          </a:xfrm>
          <a:prstGeom prst="flowChartMerg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3" name="TextBox 112"/>
          <p:cNvSpPr txBox="1"/>
          <p:nvPr/>
        </p:nvSpPr>
        <p:spPr>
          <a:xfrm>
            <a:off x="1172117" y="2302903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077748" y="2402930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039208" y="2519691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742950" y="2644953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919033" y="274498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907893" y="284500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903022" y="294104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919033" y="306051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919033" y="316392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991444" y="3257609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906134" y="337172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983130" y="3471750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900068" y="35844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938083" y="368633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938083" y="378636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943076" y="471507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943076" y="460561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938083" y="389969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919033" y="399972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943076" y="410547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942279" y="421022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244152" y="4310250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943076" y="440555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943076" y="450558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943076" y="48202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942279" y="492768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943076" y="502771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943076" y="512773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728213" y="523916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943076" y="6067567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714476" y="534390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714476" y="5430942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714476" y="5553697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714476" y="565372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714476" y="574554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714476" y="585378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982058" y="6167594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158501" y="6267621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685800" y="637840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714476" y="6482744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714476" y="668891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1244152" y="6578458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1219200" y="6945943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714476" y="594560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907893" y="6834430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180218" y="7055701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167043" y="7165164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027818" y="7265192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027818" y="736522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990600" y="747703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990600" y="7572345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46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6214" y="2206486"/>
            <a:ext cx="4223586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70626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4352" y="1580456"/>
            <a:ext cx="4041648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4" name="TextBox 163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393969" y="1685342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324076" y="1785652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300033" y="1885679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993310" y="1982526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169393" y="208255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158253" y="218258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153382" y="227862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169393" y="239809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169393" y="250149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241804" y="2595182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141602" y="269524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218598" y="2795274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135536" y="290798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173551" y="300986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173551" y="310989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171676" y="413391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1171676" y="402444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173551" y="322322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154501" y="332324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178544" y="342900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177747" y="353374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479620" y="3633774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143000" y="376234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171676" y="392442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171676" y="423909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170879" y="434651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171676" y="444654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1171676" y="454657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956813" y="465799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178544" y="5486400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943076" y="476273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943076" y="484977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943076" y="497253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943076" y="507255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943076" y="516437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943076" y="52726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217526" y="5586427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393969" y="5686454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921268" y="579723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949944" y="5901577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949944" y="610774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479620" y="5997291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440533" y="6319316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943076" y="536443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1102344" y="6212488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400276" y="6446101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1387101" y="6555564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1247876" y="6655592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247876" y="675562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1210658" y="686743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1210658" y="6962745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Flowchart: Merge 112"/>
          <p:cNvSpPr/>
          <p:nvPr/>
        </p:nvSpPr>
        <p:spPr>
          <a:xfrm>
            <a:off x="3352800" y="1676400"/>
            <a:ext cx="45719" cy="64409"/>
          </a:xfrm>
          <a:prstGeom prst="flowChartMerg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2221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8152" y="1596032"/>
            <a:ext cx="4041648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4" name="TextBox 163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Flowchart: Merge 56"/>
          <p:cNvSpPr/>
          <p:nvPr/>
        </p:nvSpPr>
        <p:spPr>
          <a:xfrm>
            <a:off x="3505200" y="1600200"/>
            <a:ext cx="45719" cy="64409"/>
          </a:xfrm>
          <a:prstGeom prst="flowChartMerg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2" name="TextBox 111"/>
          <p:cNvSpPr txBox="1"/>
          <p:nvPr/>
        </p:nvSpPr>
        <p:spPr>
          <a:xfrm>
            <a:off x="1295400" y="1679486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230148" y="1778016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191608" y="1878044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895350" y="1987586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071433" y="208761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060293" y="218764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055422" y="228368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071433" y="240315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071433" y="25065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143844" y="2600242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058534" y="27143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135530" y="2814383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052468" y="292708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090483" y="302897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090483" y="312899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128672" y="414025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128672" y="403079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090483" y="324233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071433" y="33423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135530" y="350520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127875" y="363539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1429748" y="3735426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128672" y="3830735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128672" y="393076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1128672" y="424543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1127875" y="435285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128672" y="445288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1128672" y="455291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913809" y="466433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1138978" y="5488288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900072" y="4769081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900072" y="485611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900072" y="497887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900072" y="5078901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900072" y="5170721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900072" y="527895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177960" y="5624704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1354403" y="5724731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881702" y="58355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910378" y="5939854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910378" y="614602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1440054" y="6035568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1367578" y="6346074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900072" y="537077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1062778" y="6250765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367578" y="6446101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354403" y="6555564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215178" y="6655592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215178" y="675562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177960" y="686743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1177960" y="6962745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71860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Damian\Desktop\n2.pn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0552" y="2240280"/>
            <a:ext cx="4041648" cy="5532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4" name="TextBox 163"/>
          <p:cNvSpPr txBox="1"/>
          <p:nvPr/>
        </p:nvSpPr>
        <p:spPr>
          <a:xfrm>
            <a:off x="914400" y="8001000"/>
            <a:ext cx="6011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l Figure 1 cont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476917" y="2331336"/>
            <a:ext cx="6485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vinifer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382548" y="2463816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cerevisiaae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344008" y="2563844"/>
            <a:ext cx="76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col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047750" y="2673386"/>
            <a:ext cx="10904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CCMP1545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223833" y="2773414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700" i="1" dirty="0" err="1" smtClean="0">
                <a:latin typeface="Times New Roman" pitchFamily="18" charset="0"/>
                <a:cs typeface="Times New Roman" pitchFamily="18" charset="0"/>
              </a:rPr>
              <a:t>pusilla</a:t>
            </a:r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 RCC299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212693" y="287344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H. sapien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207822" y="296948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lucimarin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223833" y="308895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moellendorff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223833" y="31923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14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296244" y="3286042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atens (65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210934" y="34001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1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287930" y="3500183"/>
            <a:ext cx="8374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ulgaris (7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204868" y="361288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sitch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242883" y="371477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57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242883" y="3814799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0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247876" y="474351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19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247876" y="4634047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max (3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242883" y="392813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distachyon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223833" y="4028158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1247876" y="413391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virgat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247079" y="423865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ital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548952" y="4338683"/>
            <a:ext cx="6070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bicolor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247876" y="4433992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Z. may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247876" y="453402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truncatu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247876" y="4848691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ativ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247079" y="4956116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guttatu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247876" y="5056143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tuberos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247876" y="5156170"/>
            <a:ext cx="914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S. lycopersicum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033013" y="526759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14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247876" y="6134277"/>
            <a:ext cx="900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trichocarpa (2g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1019276" y="537233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halophi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019276" y="5459375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B. rap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019276" y="558213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ubell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019276" y="568215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019276" y="5773978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lyra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019276" y="58822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inens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286858" y="6234304"/>
            <a:ext cx="8616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E. grand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1463301" y="6334331"/>
            <a:ext cx="662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papay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990600" y="6445113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A. caerul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019276" y="6549454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182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019276" y="6755620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G. raimondii (236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1548952" y="6645168"/>
            <a:ext cx="5763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T. cacao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476476" y="6955674"/>
            <a:ext cx="6405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F. ves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019276" y="6004466"/>
            <a:ext cx="11292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clementin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171676" y="6860365"/>
            <a:ext cx="9768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domestica (193)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476476" y="7055701"/>
            <a:ext cx="6720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P. persic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463301" y="7165164"/>
            <a:ext cx="661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R. communis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1324076" y="7265192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M. esculent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324076" y="736522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subellipsoidea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1286858" y="7477036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V. carter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1295400" y="7620000"/>
            <a:ext cx="814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>
                <a:latin typeface="Times New Roman" pitchFamily="18" charset="0"/>
                <a:cs typeface="Times New Roman" pitchFamily="18" charset="0"/>
              </a:rPr>
              <a:t>C. reinhardtii</a:t>
            </a:r>
            <a:endParaRPr lang="en-US" sz="700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67167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 xsi:nil="true"/>
    <DocumentType xmlns="ad5e6ac6-7e28-44ff-b599-4b096ee3745e">Presentation</DocumentType>
    <DocumentId xmlns="ad5e6ac6-7e28-44ff-b599-4b096ee3745e">Presentation 1.PPTX</DocumentId>
  </documentManagement>
</p:properties>
</file>

<file path=customXml/itemProps1.xml><?xml version="1.0" encoding="utf-8"?>
<ds:datastoreItem xmlns:ds="http://schemas.openxmlformats.org/officeDocument/2006/customXml" ds:itemID="{78D8A63C-590C-4F01-BCE1-EEC89B4E15BB}"/>
</file>

<file path=customXml/itemProps2.xml><?xml version="1.0" encoding="utf-8"?>
<ds:datastoreItem xmlns:ds="http://schemas.openxmlformats.org/officeDocument/2006/customXml" ds:itemID="{6E27788A-5905-4B7B-892D-469097D40B8F}"/>
</file>

<file path=customXml/itemProps3.xml><?xml version="1.0" encoding="utf-8"?>
<ds:datastoreItem xmlns:ds="http://schemas.openxmlformats.org/officeDocument/2006/customXml" ds:itemID="{79B92417-BF98-4E94-9738-E0F5497F91C0}"/>
</file>

<file path=docProps/app.xml><?xml version="1.0" encoding="utf-8"?>
<Properties xmlns="http://schemas.openxmlformats.org/officeDocument/2006/extended-properties" xmlns:vt="http://schemas.openxmlformats.org/officeDocument/2006/docPropsVTypes">
  <TotalTime>24290</TotalTime>
  <Words>2167</Words>
  <Application>Microsoft Office PowerPoint</Application>
  <PresentationFormat>Custom</PresentationFormat>
  <Paragraphs>52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partment of MC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mian Guerra</dc:creator>
  <cp:lastModifiedBy>Damian Guerra</cp:lastModifiedBy>
  <cp:revision>218</cp:revision>
  <dcterms:created xsi:type="dcterms:W3CDTF">2013-04-23T15:45:50Z</dcterms:created>
  <dcterms:modified xsi:type="dcterms:W3CDTF">2013-07-22T18:00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